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wmf" ContentType="image/x-wmf"/>
  <Override PartName="/ppt/media/image2.wmf" ContentType="image/x-wmf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907588"/>
  <p:notesSz cx="6792913" cy="992505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2DCD64F-74A3-4329-832D-D5B0D497EDF4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78C96B2-DF74-42EC-8429-D4E0B7E4AE84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346DE9B-3BA0-4A4B-88FE-33ACABFEE401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0FEFFE2-5FFD-48CF-A9BF-CFE61D4D8F6F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A1DDFC4-7BDF-4451-B400-94390727F70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3D7192E-9DD7-4E87-8C81-0D0BF3AECE5E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A9B7B80-BFF1-4847-BC1E-02D943A566E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1271DB6-FAB7-4146-A987-D58FA1179FE4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96360"/>
            <a:ext cx="6172200" cy="76557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AE98D29-A34A-4075-B5EA-58ED78AACE3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437B6BD-2FC0-4658-81EE-F8DBB11F1C6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4631D7F-7CEF-4614-B97D-59E79B11D10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C309693-4A10-42C5-B6D7-54C653FD4D8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9020160"/>
            <a:ext cx="1600200" cy="689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9020160"/>
            <a:ext cx="2171520" cy="689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9020160"/>
            <a:ext cx="1600200" cy="689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706B65CC-375D-4020-9901-731C2C870871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wmf"/><Relationship Id="rId2" Type="http://schemas.openxmlformats.org/officeDocument/2006/relationships/image" Target="../media/image2.wmf"/><Relationship Id="rId3" Type="http://schemas.openxmlformats.org/officeDocument/2006/relationships/slideLayout" Target="../slideLayouts/slideLayout3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" descr=""/>
          <p:cNvPicPr/>
          <p:nvPr/>
        </p:nvPicPr>
        <p:blipFill>
          <a:blip r:embed="rId1"/>
          <a:srcRect l="0" t="0" r="1736" b="0"/>
          <a:stretch/>
        </p:blipFill>
        <p:spPr>
          <a:xfrm>
            <a:off x="311040" y="677880"/>
            <a:ext cx="6470640" cy="3087720"/>
          </a:xfrm>
          <a:prstGeom prst="rect">
            <a:avLst/>
          </a:prstGeom>
          <a:ln w="0">
            <a:noFill/>
          </a:ln>
        </p:spPr>
      </p:pic>
      <p:pic>
        <p:nvPicPr>
          <p:cNvPr id="42" name="" descr=""/>
          <p:cNvPicPr/>
          <p:nvPr/>
        </p:nvPicPr>
        <p:blipFill>
          <a:blip r:embed="rId2"/>
          <a:srcRect l="0" t="0" r="2866" b="0"/>
          <a:stretch/>
        </p:blipFill>
        <p:spPr>
          <a:xfrm>
            <a:off x="324000" y="4373640"/>
            <a:ext cx="6457680" cy="4533840"/>
          </a:xfrm>
          <a:prstGeom prst="rect">
            <a:avLst/>
          </a:prstGeom>
          <a:ln w="0">
            <a:noFill/>
          </a:ln>
        </p:spPr>
      </p:pic>
      <p:sp>
        <p:nvSpPr>
          <p:cNvPr id="43" name=""/>
          <p:cNvSpPr/>
          <p:nvPr/>
        </p:nvSpPr>
        <p:spPr>
          <a:xfrm>
            <a:off x="152280" y="104760"/>
            <a:ext cx="9144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800" spc="-1" strike="noStrike">
                <a:solidFill>
                  <a:srgbClr val="000000"/>
                </a:solidFill>
                <a:latin typeface="Arial"/>
              </a:rPr>
              <a:t>S1A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"/>
          <p:cNvSpPr/>
          <p:nvPr/>
        </p:nvSpPr>
        <p:spPr>
          <a:xfrm>
            <a:off x="133200" y="3933720"/>
            <a:ext cx="12859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800" spc="-1" strike="noStrike">
                <a:solidFill>
                  <a:srgbClr val="000000"/>
                </a:solidFill>
                <a:latin typeface="Arial"/>
              </a:rPr>
              <a:t>S1B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"/>
          <p:cNvSpPr/>
          <p:nvPr/>
        </p:nvSpPr>
        <p:spPr>
          <a:xfrm rot="16200000">
            <a:off x="-704520" y="2133000"/>
            <a:ext cx="19335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Tumour volume (mm</a:t>
            </a:r>
            <a:r>
              <a:rPr b="0" lang="en-GB" sz="1200" spc="-1" strike="noStrike" baseline="30000">
                <a:solidFill>
                  <a:srgbClr val="000000"/>
                </a:solidFill>
                <a:latin typeface="Arial"/>
              </a:rPr>
              <a:t>3</a:t>
            </a: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"/>
          <p:cNvSpPr/>
          <p:nvPr/>
        </p:nvSpPr>
        <p:spPr>
          <a:xfrm rot="16200000">
            <a:off x="-713880" y="6415920"/>
            <a:ext cx="19335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Tumour volume (mm</a:t>
            </a:r>
            <a:r>
              <a:rPr b="0" lang="en-GB" sz="1200" spc="-1" strike="noStrike" baseline="30000">
                <a:solidFill>
                  <a:srgbClr val="000000"/>
                </a:solidFill>
                <a:latin typeface="Arial"/>
              </a:rPr>
              <a:t>3</a:t>
            </a: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"/>
          <p:cNvSpPr/>
          <p:nvPr/>
        </p:nvSpPr>
        <p:spPr>
          <a:xfrm>
            <a:off x="2171880" y="3714840"/>
            <a:ext cx="35715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Time after start of treatment (days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"/>
          <p:cNvSpPr/>
          <p:nvPr/>
        </p:nvSpPr>
        <p:spPr>
          <a:xfrm>
            <a:off x="2187720" y="8854920"/>
            <a:ext cx="35715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Time after start of treatment (days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592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7-08-08T15:24:08Z</dcterms:created>
  <dc:creator>Guy Makin</dc:creator>
  <dc:description/>
  <dc:language>en-US</dc:language>
  <cp:lastModifiedBy>KC.Lalitha</cp:lastModifiedBy>
  <dcterms:modified xsi:type="dcterms:W3CDTF">2009-05-20T11:07:37Z</dcterms:modified>
  <cp:revision>12</cp:revision>
  <dc:subject/>
  <dc:title>Slide 1</dc:title>
</cp:coreProperties>
</file>